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6" r:id="rId4"/>
    <p:sldId id="257" r:id="rId5"/>
    <p:sldId id="259" r:id="rId6"/>
    <p:sldId id="258" r:id="rId7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08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2 Subtítulo">
            <a:extLst>
              <a:ext uri="{FF2B5EF4-FFF2-40B4-BE49-F238E27FC236}">
                <a16:creationId xmlns:a16="http://schemas.microsoft.com/office/drawing/2014/main" id="{BED305E4-BBFD-4C7D-A004-CFA4CD43F04E}"/>
              </a:ext>
            </a:extLst>
          </p:cNvPr>
          <p:cNvSpPr txBox="1">
            <a:spLocks/>
          </p:cNvSpPr>
          <p:nvPr/>
        </p:nvSpPr>
        <p:spPr>
          <a:xfrm>
            <a:off x="1547664" y="5373216"/>
            <a:ext cx="6400800" cy="1752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pec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60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e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io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tri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u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ring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L pots containing coarse sand to ensure complete drain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E6513A20-65E4-4F3F-B61C-6507F7161177}"/>
              </a:ext>
            </a:extLst>
          </p:cNvPr>
          <p:cNvGrpSpPr/>
          <p:nvPr/>
        </p:nvGrpSpPr>
        <p:grpSpPr>
          <a:xfrm>
            <a:off x="0" y="0"/>
            <a:ext cx="9144000" cy="5143500"/>
            <a:chOff x="0" y="0"/>
            <a:chExt cx="9144000" cy="5143500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AAEF8084-CFE2-4AA8-8A1C-AFC8FC220F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9144000" cy="5143500"/>
            </a:xfrm>
            <a:prstGeom prst="rect">
              <a:avLst/>
            </a:prstGeom>
          </p:spPr>
        </p:pic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4B482499-817F-457E-A76F-B433FA2DE745}"/>
                </a:ext>
              </a:extLst>
            </p:cNvPr>
            <p:cNvSpPr txBox="1"/>
            <p:nvPr/>
          </p:nvSpPr>
          <p:spPr>
            <a:xfrm>
              <a:off x="323528" y="4437112"/>
              <a:ext cx="18722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DK x DV </a:t>
              </a:r>
              <a:r>
                <a:rPr lang="es-ES" sz="1400" dirty="0" err="1"/>
                <a:t>Backcross</a:t>
              </a:r>
              <a:r>
                <a:rPr lang="es-ES" sz="1400" dirty="0"/>
                <a:t> (BC)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2497861E-8D47-4B81-8A81-AD8C4BAC1120}"/>
                </a:ext>
              </a:extLst>
            </p:cNvPr>
            <p:cNvSpPr txBox="1"/>
            <p:nvPr/>
          </p:nvSpPr>
          <p:spPr>
            <a:xfrm>
              <a:off x="2627784" y="4454624"/>
              <a:ext cx="18722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/>
                <a:t>D. kaki (DK)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B913CE7F-11CB-4D43-BEBB-AC3D899D7A78}"/>
                </a:ext>
              </a:extLst>
            </p:cNvPr>
            <p:cNvSpPr txBox="1"/>
            <p:nvPr/>
          </p:nvSpPr>
          <p:spPr>
            <a:xfrm>
              <a:off x="4759457" y="4459560"/>
              <a:ext cx="18722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/>
                <a:t>D.  virginiana (DV)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D1FAD5FA-458C-4AF8-8655-ACC1C924225A}"/>
                </a:ext>
              </a:extLst>
            </p:cNvPr>
            <p:cNvSpPr txBox="1"/>
            <p:nvPr/>
          </p:nvSpPr>
          <p:spPr>
            <a:xfrm>
              <a:off x="6960417" y="4454624"/>
              <a:ext cx="18722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/>
                <a:t>D.  </a:t>
              </a:r>
              <a:r>
                <a:rPr lang="es-ES" sz="1400" dirty="0" err="1"/>
                <a:t>lotus</a:t>
              </a:r>
              <a:r>
                <a:rPr lang="es-ES" sz="1400" dirty="0"/>
                <a:t> (DL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32853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20881C01-C1DB-41A7-BB34-C54E3943AB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8640"/>
            <a:ext cx="9144000" cy="5143500"/>
          </a:xfrm>
          <a:prstGeom prst="rect">
            <a:avLst/>
          </a:prstGeom>
        </p:spPr>
      </p:pic>
      <p:sp>
        <p:nvSpPr>
          <p:cNvPr id="6" name="2 Subtítulo">
            <a:extLst>
              <a:ext uri="{FF2B5EF4-FFF2-40B4-BE49-F238E27FC236}">
                <a16:creationId xmlns:a16="http://schemas.microsoft.com/office/drawing/2014/main" id="{7AAD27EB-9748-427E-ADDD-38039F1E05B3}"/>
              </a:ext>
            </a:extLst>
          </p:cNvPr>
          <p:cNvSpPr txBox="1">
            <a:spLocks/>
          </p:cNvSpPr>
          <p:nvPr/>
        </p:nvSpPr>
        <p:spPr>
          <a:xfrm>
            <a:off x="1259632" y="5661248"/>
            <a:ext cx="6400800" cy="1752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ma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mptom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t-induc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mag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D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ampl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e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0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tri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u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0mM NaCl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L pots containing coarse sand to ensure complete drain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83762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pPr algn="l"/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gure 3)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ibution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bles to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rst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mension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incipal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onent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aysis</a:t>
            </a:r>
            <a:r>
              <a:rPr lang="es-E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1026" name="Picture 2" descr="D:\MEGA\Doctorado\Papers\Patrones 2\SupplementaryFigureS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648" y="476672"/>
            <a:ext cx="6480175" cy="2643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508050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MEGA\Doctorado\Papers\Patrones 2\SupplementaryFigureS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137" y="1052736"/>
            <a:ext cx="2879725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2 Subtítulo"/>
          <p:cNvSpPr txBox="1">
            <a:spLocks/>
          </p:cNvSpPr>
          <p:nvPr/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logra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phologica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iable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es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531558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D:\MEGA\Doctorado\Papers\Patrones 2\SupplementaryFigureS3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844550"/>
            <a:ext cx="6480175" cy="2584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2 Subtítulo"/>
          <p:cNvSpPr txBox="1">
            <a:spLocks/>
          </p:cNvSpPr>
          <p:nvPr/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) Box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ske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t-tolerance-rel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9366090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D:\MEGA\Doctorado\Papers\Patrones 2\SupplementaryFigureS4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138" y="1646238"/>
            <a:ext cx="2879725" cy="3565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2 Subtítulo"/>
          <p:cNvSpPr txBox="1">
            <a:spLocks/>
          </p:cNvSpPr>
          <p:nvPr/>
        </p:nvSpPr>
        <p:spPr>
          <a:xfrm>
            <a:off x="1371600" y="5348808"/>
            <a:ext cx="6400800" cy="1752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6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ighbor-Join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00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otstrap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IP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tativ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s-E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tus</a:t>
            </a:r>
            <a:r>
              <a:rPr lang="es-E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IP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s-E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liana</a:t>
            </a:r>
            <a:endParaRPr lang="es-E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02304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215</Words>
  <Application>Microsoft Office PowerPoint</Application>
  <PresentationFormat>Presentación en pantalla (4:3)</PresentationFormat>
  <Paragraphs>10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cisco</dc:creator>
  <cp:lastModifiedBy>BADENES CATALÁ, Mª LUISA</cp:lastModifiedBy>
  <cp:revision>6</cp:revision>
  <dcterms:created xsi:type="dcterms:W3CDTF">2020-03-11T12:14:14Z</dcterms:created>
  <dcterms:modified xsi:type="dcterms:W3CDTF">2020-07-08T08:01:45Z</dcterms:modified>
</cp:coreProperties>
</file>